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0238" autoAdjust="0"/>
    <p:restoredTop sz="99861" autoAdjust="0"/>
  </p:normalViewPr>
  <p:slideViewPr>
    <p:cSldViewPr snapToGrid="0" snapToObjects="1">
      <p:cViewPr>
        <p:scale>
          <a:sx n="100" d="100"/>
          <a:sy n="100" d="100"/>
        </p:scale>
        <p:origin x="-60" y="654"/>
      </p:cViewPr>
      <p:guideLst>
        <p:guide orient="horz" pos="54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DE1661-0E2A-5A4E-8372-56F43A40E6AE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2588F1-F3A2-9D40-B848-C8C54D5D02D8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39179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8E59C9-1983-F747-90F3-E1A76D024CD7}" type="datetimeFigureOut">
              <a:rPr lang="de-DE" smtClean="0"/>
              <a:pPr/>
              <a:t>28.06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6A8308-A7FC-A549-86A7-873A76C0CA64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3216001"/>
              </p:ext>
            </p:extLst>
          </p:nvPr>
        </p:nvGraphicFramePr>
        <p:xfrm>
          <a:off x="1524000" y="1171574"/>
          <a:ext cx="6095999" cy="546735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70857"/>
                <a:gridCol w="870857"/>
                <a:gridCol w="870857"/>
                <a:gridCol w="870857"/>
                <a:gridCol w="870857"/>
                <a:gridCol w="870857"/>
                <a:gridCol w="870857"/>
              </a:tblGrid>
              <a:tr h="386788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Sarcoma Subtype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M</a:t>
                      </a:r>
                      <a:r>
                        <a:rPr lang="de-DE" sz="500" b="1" baseline="-25000">
                          <a:effectLst/>
                          <a:latin typeface="Arial"/>
                          <a:ea typeface="Cambria"/>
                          <a:cs typeface="Times New Roman"/>
                        </a:rPr>
                        <a:t>0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M</a:t>
                      </a:r>
                      <a:r>
                        <a:rPr lang="de-DE" sz="500" b="1" baseline="-25000">
                          <a:effectLst/>
                          <a:latin typeface="Arial"/>
                          <a:ea typeface="Cambria"/>
                          <a:cs typeface="Times New Roman"/>
                        </a:rPr>
                        <a:t>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Current Chemotherapy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Current Radiotherapy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nticoagulation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Fusion gene type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92078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synovial sarcoma (screening cohort)  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SS18-SSX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72871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synovial sarcoma (screening cohort) 2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SS18-SSX2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83468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synovial sarcoma (screening cohort)  3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No tumor tissue available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74195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synovial sarcoma (screening cohort)  4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SS18-SSX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8479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synovial sarcoma (screening cohort) 5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SS18-SSX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55651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synovial sarcoma (independent Cohort ) 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SS18-SSX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86117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synovial sarcoma (Independent Cohort) 2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SS18-SSX2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76845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synovial sarcoma (Independent Cohort) 3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SS18-SSX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37768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leiomyosarcoma 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58954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 dirty="0" err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</a:t>
                      </a:r>
                      <a:r>
                        <a:rPr lang="de-DE" sz="500" b="1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 </a:t>
                      </a:r>
                      <a:r>
                        <a:rPr lang="de-DE" sz="500" b="1" dirty="0" err="1">
                          <a:effectLst/>
                          <a:latin typeface="Arial"/>
                          <a:ea typeface="Cambria"/>
                          <a:cs typeface="Times New Roman"/>
                        </a:rPr>
                        <a:t>leiomyosarcoma</a:t>
                      </a:r>
                      <a:r>
                        <a:rPr lang="de-DE" sz="500" b="1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 2</a:t>
                      </a:r>
                      <a:endParaRPr lang="de-DE" sz="5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78823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 dirty="0" err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</a:t>
                      </a:r>
                      <a:r>
                        <a:rPr lang="de-DE" sz="500" b="1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 </a:t>
                      </a:r>
                      <a:r>
                        <a:rPr lang="de-DE" sz="500" b="1" dirty="0" err="1">
                          <a:effectLst/>
                          <a:latin typeface="Arial"/>
                          <a:ea typeface="Cambria"/>
                          <a:cs typeface="Times New Roman"/>
                        </a:rPr>
                        <a:t>leiomyosarcoma</a:t>
                      </a:r>
                      <a:r>
                        <a:rPr lang="de-DE" sz="500" b="1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 3</a:t>
                      </a:r>
                      <a:endParaRPr lang="de-DE" sz="5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08627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 dirty="0" err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</a:t>
                      </a:r>
                      <a:r>
                        <a:rPr lang="de-DE" sz="500" b="1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 </a:t>
                      </a:r>
                      <a:r>
                        <a:rPr lang="de-DE" sz="500" b="1" dirty="0" err="1">
                          <a:effectLst/>
                          <a:latin typeface="Arial"/>
                          <a:ea typeface="Cambria"/>
                          <a:cs typeface="Times New Roman"/>
                        </a:rPr>
                        <a:t>leiomyosarcoma</a:t>
                      </a:r>
                      <a:r>
                        <a:rPr lang="de-DE" sz="500" b="1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 4</a:t>
                      </a:r>
                      <a:endParaRPr lang="de-DE" sz="5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208627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leiomyosarcoma 5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78823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MPNST 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58954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MPNST 2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58954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MPNST 3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88758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Ewing Sarcoma 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88758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Ewing Sarcoma 2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49019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Ewing Sarcoma 3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39085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liposarcoma 1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49019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liposarcoma 2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23189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liposarcoma 3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49019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liposarcoma 4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39085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liposarcoma 5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  <a:tr h="139085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b="1">
                          <a:effectLst/>
                          <a:latin typeface="Arial"/>
                          <a:ea typeface="Cambria"/>
                          <a:cs typeface="Times New Roman"/>
                        </a:rPr>
                        <a:t>Active liposarcoma 6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X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de-DE" sz="500" dirty="0">
                          <a:effectLst/>
                          <a:latin typeface="Arial"/>
                          <a:ea typeface="Cambria"/>
                          <a:cs typeface="Times New Roman"/>
                        </a:rPr>
                        <a:t> </a:t>
                      </a:r>
                      <a:endParaRPr lang="de-DE" sz="5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8580" marR="68580" marT="0" marB="0"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9</Words>
  <Application>Microsoft Office PowerPoint</Application>
  <PresentationFormat>Bildschirmpräsentation (4:3)</PresentationFormat>
  <Paragraphs>18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priva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lba Fricke</dc:creator>
  <cp:lastModifiedBy>144888</cp:lastModifiedBy>
  <cp:revision>35</cp:revision>
  <dcterms:created xsi:type="dcterms:W3CDTF">2015-05-24T10:05:58Z</dcterms:created>
  <dcterms:modified xsi:type="dcterms:W3CDTF">2015-06-28T20:11:03Z</dcterms:modified>
</cp:coreProperties>
</file>